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39FD8-A2E4-4770-A6F5-3D9077E818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2DEE42-F043-4341-A224-2E1E412E2F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70005F-D196-4BAB-83B8-790D3E55B8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781C1-8AF7-4ACB-9F22-C36867976D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24ADF9-E45A-4BC2-AAFB-E427853921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BF64C86-7D95-4C9E-9BA2-C98CC4695C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886D0FB-F108-4235-BFE1-A86EE47AFF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5179EF1-5379-4C30-9EBB-4C3A3434EB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4634EE5-655C-498B-A3E2-7CCE02ADE3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5E07D5-6C3F-4BDB-B5A1-C58B312F62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D4BCB9C-B7F1-4661-9665-8B3CD460E9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CE174-5CC5-45C7-BAE3-D9C3FD527E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716517-0FB1-4FEA-835C-0D502B537E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B66F404-A3B6-493A-A9F3-AD7D00211A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6B55D45-E300-4E56-840B-85029F1EC8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BF50756-B9DF-424C-95BF-0016C9602D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3BC8047-DB79-4DC3-83D8-534D514695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DF85E-A386-4B75-B847-5E48EA54B8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93E14-7ADB-4201-8704-BA77088B53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67A96-9B3C-4ED5-ACCE-EDFB66CDC2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618D9-0993-4C6C-A84D-EC7E2156F4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8696D-FAE3-497D-BDDB-B95F82AF98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BAE8D-0D19-450A-900C-C0C6D390DA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BC559-5BB7-42C8-A0AF-C60078FF1A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706B6A-B257-40B6-AD4A-C590623C2748}" type="slidenum">
              <a:rPr b="0" lang="de-DE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2FA0E9-1DB5-4073-922C-FC1471C5EACF}" type="slidenum">
              <a:rPr b="0" lang="de-DE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2" name=""/>
          <p:cNvGraphicFramePr/>
          <p:nvPr/>
        </p:nvGraphicFramePr>
        <p:xfrm>
          <a:off x="826920" y="260280"/>
          <a:ext cx="8258400" cy="6229440"/>
        </p:xfrm>
        <a:graphic>
          <a:graphicData uri="http://schemas.openxmlformats.org/drawingml/2006/table">
            <a:tbl>
              <a:tblPr/>
              <a:tblGrid>
                <a:gridCol w="947880"/>
                <a:gridCol w="735120"/>
                <a:gridCol w="882720"/>
                <a:gridCol w="661680"/>
                <a:gridCol w="882720"/>
                <a:gridCol w="955800"/>
                <a:gridCol w="1103400"/>
                <a:gridCol w="1030320"/>
                <a:gridCol w="1058760"/>
              </a:tblGrid>
              <a:tr h="96696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Varia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ocula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mbryo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ansgen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genera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scap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ansgen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depend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lines SM(+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-transgen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genera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M(+)GOI(+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dependent co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ansgenic li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M(+)GOI(+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dependent co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ansgenic li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oducing gree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H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dependent co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ansgenic li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oducing SM-free GOI(+) DH progen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588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trol 1,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588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440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trol 3,4,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440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 (Control 6,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588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588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404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trol 9,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588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440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trol 11,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404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trol 13,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8520"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um contr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3" name="Text Box 2153"/>
          <p:cNvSpPr/>
          <p:nvPr/>
        </p:nvSpPr>
        <p:spPr>
          <a:xfrm>
            <a:off x="-38160" y="6237360"/>
            <a:ext cx="88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Calibri"/>
                <a:ea typeface="Arial"/>
              </a:rPr>
              <a:t>Table S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15T09:08:48Z</dcterms:created>
  <dc:creator>kumlehn</dc:creator>
  <dc:description/>
  <dc:language>en-US</dc:language>
  <cp:lastModifiedBy>kumlehn</cp:lastModifiedBy>
  <dcterms:modified xsi:type="dcterms:W3CDTF">2012-10-15T09:19:33Z</dcterms:modified>
  <cp:revision>1</cp:revision>
  <dc:subject/>
  <dc:title>Folie 1</dc:title>
</cp:coreProperties>
</file>